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Объект 2">
            <a:extLst>
              <a:ext uri="{FF2B5EF4-FFF2-40B4-BE49-F238E27FC236}">
                <a16:creationId xmlns:a16="http://schemas.microsoft.com/office/drawing/2014/main" xmlns="" id="{B5A1926C-F1CF-5BDA-0061-F4962B0CECDA}"/>
              </a:ext>
            </a:extLst>
          </p:cNvPr>
          <p:cNvSpPr txBox="1">
            <a:spLocks/>
          </p:cNvSpPr>
          <p:nvPr/>
        </p:nvSpPr>
        <p:spPr>
          <a:xfrm>
            <a:off x="155448" y="5943600"/>
            <a:ext cx="8862822" cy="762000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erarchical cluster analysis of DEGs in IS-s vs. IR-s and IS-f vs. IR-f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as well as IA-s vs. IR-s and IA-f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-f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Each row represents a DEG; n = 3 per group.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nn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ram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s two sets of DEG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8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Gs in “a” and 46 DEGs in “b”) in striatum and FC. Hierarchical cluster analysi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Gs that lie within the intersection on Venn diagram. Only those genes with cut-off &gt;1.5 and </a:t>
            </a:r>
            <a:r>
              <a:rPr lang="en-US" sz="14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Прямоугольник 8"/>
          <p:cNvSpPr/>
          <p:nvPr/>
        </p:nvSpPr>
        <p:spPr>
          <a:xfrm>
            <a:off x="169865" y="76200"/>
            <a:ext cx="8745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fferential expressed genes </a:t>
            </a:r>
            <a:r>
              <a:rPr lang="en-US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tha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howed </a:t>
            </a:r>
            <a:r>
              <a:rPr lang="en-US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opposite-directed changes in expression in </a:t>
            </a:r>
            <a:r>
              <a:rPr lang="en-GB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FC and striatum under </a:t>
            </a:r>
            <a:r>
              <a:rPr lang="en-GB" sz="1400" b="1" dirty="0" err="1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Semax</a:t>
            </a:r>
            <a:r>
              <a:rPr lang="en-GB" sz="1400" b="1" dirty="0" smtClean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 and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H(6-9)PGP peptides action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h 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GB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1026" name="Picture 2" descr="G:\Редактируемые\Для публикаций\0_текущие публикации\ишемия_2\стриатум 24h\статья по 24 часам striat\2_pept-str\вар3\в журнал IJMS\раунд 1\fs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8512" y="749229"/>
            <a:ext cx="7562088" cy="49657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2279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135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OMOGC</cp:lastModifiedBy>
  <cp:revision>11</cp:revision>
  <dcterms:created xsi:type="dcterms:W3CDTF">2006-08-16T00:00:00Z</dcterms:created>
  <dcterms:modified xsi:type="dcterms:W3CDTF">2025-06-21T17:45:47Z</dcterms:modified>
</cp:coreProperties>
</file>